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60" y="3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4EBD6C-AFF3-21DB-558B-CAE65748AB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FB72162-5732-E313-9AB5-A704804097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D39765-C706-29A8-8D30-A9D12474A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DB0773-642C-7840-6660-87FAA8043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274C90-46C3-3516-66CB-32426936E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766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2B677B-06DC-73E0-CC39-063ED9C74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6EF3177-F470-FBEA-4B0E-5D1BB7A10D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9D8FA4-C4FC-9E8E-8289-CF7B8EDC3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C329FC-49EB-80AD-FC8E-0FCF8B47E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F74285-56B1-EFE8-5726-CFDCA7E9C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3118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8D237FB-5F34-F95F-670A-0BB157B7F1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AF7EA57-4B67-D6FE-7095-4C8D999A01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CC5506-F9B8-7E58-4567-7B2B41724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D78F2E-9527-2A78-89B7-4112FF6F2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EB430E8-2E0A-B37E-8818-9C95BBB24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577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AAF46B-0CED-AE1C-D26A-D6DCCFB26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656C39-9196-359D-B1E1-1A793108D3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FC030D-CDF5-B2FE-16F6-A50185CE2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FAC0AF-4087-3438-512E-6FBE9D94A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7E3EF0-B63D-0476-2E75-5F8F603F5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30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C1E0C0-8F17-E01E-084C-6E34F8C3C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D98212-053A-717B-0ADB-21A39A36B5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4B5FEE-2A60-15E9-7340-52FEA3CF1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100854-4CEE-894C-B80C-4522F8EA4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E1901A-7931-3F7F-36C5-86F8E4666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355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8CF07B-CBD3-7DDA-AE4C-27469BE2D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42E841E-842C-02BB-0CB4-8358693BF7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94A618-36C8-5E0B-4DAF-F2A4C894CC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611CDD-BBBC-2CFB-3C6D-95E106D7B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8C1817-F9D4-2501-6515-B9E300CF6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9E2517-8611-AFBE-11CC-F980A78CB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904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E9B27D-32D3-835E-72F5-47E5EB0CE8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4DCE68-9E32-F245-5307-E7D1C20B8F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DEF266B-99BD-2176-8504-D92DFA1928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D1D8270-FDC9-7717-F58D-DFCCFC6F68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54E9C5A-53EE-574C-DF68-C745B7BEC4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C5F1BC-9C4D-3181-6636-48498A405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0FF4023-2BFB-0A26-DAA7-4630F287B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6A139CF-28B1-9118-BDD2-682EE85FF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613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EC057A-9A42-791B-E9CC-669E45DE4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DB009F-70ED-11F0-766C-7CFE6D5A6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D73F70D-B490-4E6D-2011-DDCFF65B2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A9D4DA7-708F-B58B-F90E-D25D90F64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6090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D6DA221-053B-BE8D-EF6F-B769F8069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AF8D87-EE7F-6575-28FD-1A754FF40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F81943B-5B5A-1771-AF2B-D1A03D5D2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123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24400B-C57B-434A-B5C7-558D93C4B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275AD3-A24E-E1ED-B6AF-D6E201AD92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4302E6B-00A7-A2AB-CD20-6D213CFA68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86121C-B0BE-6058-07A8-AD632B806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84915AC-6686-1CDA-C351-A3BFFE92D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1270A5-0325-78CB-9FE6-6BDE48266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801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B934E4-72FB-8942-CA37-334FFCBED0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AE5F39C-ECBF-CAB4-EFA6-C342AADE66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617F4FB-9035-5199-1A42-77F2162A2B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5887C8-CE35-3B4D-ADF1-8470C1290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0CB4D1-621C-F846-DA11-3BE4DDA13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E295EF-DBE9-AB0C-932C-F6DA5CF01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1429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C5182DA-0F2A-B0E0-E853-CC0A05626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DC12E2-CC5C-DE64-1794-C35D794191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C3CEE6-B1D3-BD73-2C19-F61135B05D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EBE65-0444-40CA-B893-551EF9451A49}" type="datetimeFigureOut">
              <a:rPr lang="zh-CN" altLang="en-US" smtClean="0"/>
              <a:t>2025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A65E5F-C416-E042-B18C-C8379FA732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2FA1CC-B5D8-3DFF-655E-BD50F2FC32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992F4-B590-4F2D-9052-45892F3D5B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6036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组合 89">
            <a:extLst>
              <a:ext uri="{FF2B5EF4-FFF2-40B4-BE49-F238E27FC236}">
                <a16:creationId xmlns:a16="http://schemas.microsoft.com/office/drawing/2014/main" id="{0F2727E0-DFFC-7EFA-7CA9-31405C5827EC}"/>
              </a:ext>
            </a:extLst>
          </p:cNvPr>
          <p:cNvGrpSpPr/>
          <p:nvPr/>
        </p:nvGrpSpPr>
        <p:grpSpPr>
          <a:xfrm>
            <a:off x="2744540" y="149909"/>
            <a:ext cx="7014268" cy="6378371"/>
            <a:chOff x="2744540" y="149909"/>
            <a:chExt cx="7014268" cy="637837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444846F-5BAF-65A9-2FB2-FF5BA79EC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43" t="3045" r="33086" b="55484"/>
            <a:stretch/>
          </p:blipFill>
          <p:spPr>
            <a:xfrm>
              <a:off x="2773180" y="2714616"/>
              <a:ext cx="5760000" cy="3813664"/>
            </a:xfrm>
            <a:prstGeom prst="rect">
              <a:avLst/>
            </a:prstGeom>
          </p:spPr>
        </p:pic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576736C4-BC5B-61F1-F47B-ABD21CEA38C3}"/>
                </a:ext>
              </a:extLst>
            </p:cNvPr>
            <p:cNvGrpSpPr/>
            <p:nvPr/>
          </p:nvGrpSpPr>
          <p:grpSpPr>
            <a:xfrm>
              <a:off x="3500616" y="149909"/>
              <a:ext cx="2196313" cy="2858143"/>
              <a:chOff x="3500616" y="149909"/>
              <a:chExt cx="2196313" cy="2858143"/>
            </a:xfrm>
          </p:grpSpPr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26A61181-2499-3119-E672-E69B0D318CDF}"/>
                  </a:ext>
                </a:extLst>
              </p:cNvPr>
              <p:cNvSpPr txBox="1"/>
              <p:nvPr/>
            </p:nvSpPr>
            <p:spPr>
              <a:xfrm rot="18348356">
                <a:off x="3599341" y="1815789"/>
                <a:ext cx="17102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A86E9E04-36F6-2559-93D4-B52138622E2B}"/>
                  </a:ext>
                </a:extLst>
              </p:cNvPr>
              <p:cNvSpPr txBox="1"/>
              <p:nvPr/>
            </p:nvSpPr>
            <p:spPr>
              <a:xfrm rot="18348356">
                <a:off x="3182229" y="2098928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6EACA23-4304-1D8A-A9F1-2520C2F25AFC}"/>
                  </a:ext>
                </a:extLst>
              </p:cNvPr>
              <p:cNvSpPr txBox="1"/>
              <p:nvPr/>
            </p:nvSpPr>
            <p:spPr>
              <a:xfrm rot="18348356">
                <a:off x="3433949" y="2012233"/>
                <a:ext cx="11891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F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091C861-AD5E-3708-EABB-9EFE930E3876}"/>
                  </a:ext>
                </a:extLst>
              </p:cNvPr>
              <p:cNvSpPr txBox="1"/>
              <p:nvPr/>
            </p:nvSpPr>
            <p:spPr>
              <a:xfrm rot="18348356">
                <a:off x="3839043" y="1582852"/>
                <a:ext cx="227107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nmt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9D5D0EDF-F9AE-0413-882B-B159A64FFFF8}"/>
                  </a:ext>
                </a:extLst>
              </p:cNvPr>
              <p:cNvSpPr txBox="1"/>
              <p:nvPr/>
            </p:nvSpPr>
            <p:spPr>
              <a:xfrm rot="18348356">
                <a:off x="4045606" y="1440225"/>
                <a:ext cx="2858143" cy="2775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75000"/>
                  </a:lnSpc>
                </a:pP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nmt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CCC2EC98-79AC-99E0-6566-5314F2B0A909}"/>
                  </a:ext>
                </a:extLst>
              </p:cNvPr>
              <p:cNvSpPr txBox="1"/>
              <p:nvPr/>
            </p:nvSpPr>
            <p:spPr>
              <a:xfrm rot="18348356">
                <a:off x="4688658" y="2037071"/>
                <a:ext cx="1220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0302F033-7FAF-13F3-3C4D-AEED36C9C307}"/>
                  </a:ext>
                </a:extLst>
              </p:cNvPr>
              <p:cNvSpPr txBox="1"/>
              <p:nvPr/>
            </p:nvSpPr>
            <p:spPr>
              <a:xfrm rot="18348356">
                <a:off x="5039988" y="2147049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4F3A9EF-8F2C-7B45-05AD-B505FF7AB52C}"/>
                </a:ext>
              </a:extLst>
            </p:cNvPr>
            <p:cNvSpPr txBox="1"/>
            <p:nvPr/>
          </p:nvSpPr>
          <p:spPr>
            <a:xfrm>
              <a:off x="5353737" y="4319538"/>
              <a:ext cx="9936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mt1</a:t>
              </a:r>
              <a:r>
                <a:rPr lang="en-US" altLang="zh-CN" sz="16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zh-CN" altLang="en-US" sz="1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DE66BEA-3F7B-32F2-761E-5654F9A277B7}"/>
                </a:ext>
              </a:extLst>
            </p:cNvPr>
            <p:cNvSpPr txBox="1"/>
            <p:nvPr/>
          </p:nvSpPr>
          <p:spPr>
            <a:xfrm>
              <a:off x="5494015" y="5055208"/>
              <a:ext cx="6794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78D6B710-DE4A-E351-779A-0FB316F69D78}"/>
                </a:ext>
              </a:extLst>
            </p:cNvPr>
            <p:cNvSpPr/>
            <p:nvPr/>
          </p:nvSpPr>
          <p:spPr>
            <a:xfrm>
              <a:off x="3798093" y="4640713"/>
              <a:ext cx="1434549" cy="13358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0" name="直接箭头连接符 39">
              <a:extLst>
                <a:ext uri="{FF2B5EF4-FFF2-40B4-BE49-F238E27FC236}">
                  <a16:creationId xmlns:a16="http://schemas.microsoft.com/office/drawing/2014/main" id="{14A0ACFE-21FD-9A95-75D0-1E12ECA2BD51}"/>
                </a:ext>
              </a:extLst>
            </p:cNvPr>
            <p:cNvCxnSpPr>
              <a:cxnSpLocks/>
              <a:endCxn id="23" idx="1"/>
            </p:cNvCxnSpPr>
            <p:nvPr/>
          </p:nvCxnSpPr>
          <p:spPr>
            <a:xfrm>
              <a:off x="5226716" y="4895890"/>
              <a:ext cx="267299" cy="32859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01502ECC-F549-173E-BF8D-805CA13A2BA1}"/>
                </a:ext>
              </a:extLst>
            </p:cNvPr>
            <p:cNvSpPr/>
            <p:nvPr/>
          </p:nvSpPr>
          <p:spPr>
            <a:xfrm>
              <a:off x="4378395" y="4521105"/>
              <a:ext cx="552365" cy="15542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2" name="直接箭头连接符 41">
              <a:extLst>
                <a:ext uri="{FF2B5EF4-FFF2-40B4-BE49-F238E27FC236}">
                  <a16:creationId xmlns:a16="http://schemas.microsoft.com/office/drawing/2014/main" id="{6FB16145-4F36-D416-753E-6DB01BFE9A4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72076" y="4442648"/>
              <a:ext cx="431386" cy="13358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6" name="组合 65">
              <a:extLst>
                <a:ext uri="{FF2B5EF4-FFF2-40B4-BE49-F238E27FC236}">
                  <a16:creationId xmlns:a16="http://schemas.microsoft.com/office/drawing/2014/main" id="{250DC246-B9DB-25D7-CC0B-0E9FBE28E5A3}"/>
                </a:ext>
              </a:extLst>
            </p:cNvPr>
            <p:cNvGrpSpPr/>
            <p:nvPr/>
          </p:nvGrpSpPr>
          <p:grpSpPr>
            <a:xfrm>
              <a:off x="6349304" y="149909"/>
              <a:ext cx="2196313" cy="2858143"/>
              <a:chOff x="3500616" y="149909"/>
              <a:chExt cx="2196313" cy="2858143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14D94269-C8C5-4007-D143-9D3FB42E6C1C}"/>
                  </a:ext>
                </a:extLst>
              </p:cNvPr>
              <p:cNvSpPr txBox="1"/>
              <p:nvPr/>
            </p:nvSpPr>
            <p:spPr>
              <a:xfrm rot="18348356">
                <a:off x="3599341" y="1815789"/>
                <a:ext cx="17102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9881C5C7-CC1E-35BC-AAB4-EADB6ABC8C80}"/>
                  </a:ext>
                </a:extLst>
              </p:cNvPr>
              <p:cNvSpPr txBox="1"/>
              <p:nvPr/>
            </p:nvSpPr>
            <p:spPr>
              <a:xfrm rot="18348356">
                <a:off x="3182229" y="2098928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85D4FCB8-3A6A-4B7E-7AE3-60B21B53DDAC}"/>
                  </a:ext>
                </a:extLst>
              </p:cNvPr>
              <p:cNvSpPr txBox="1"/>
              <p:nvPr/>
            </p:nvSpPr>
            <p:spPr>
              <a:xfrm rot="18348356">
                <a:off x="3433949" y="2012233"/>
                <a:ext cx="11891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F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ABB09A93-FA8D-2179-B933-F4B3125C7693}"/>
                  </a:ext>
                </a:extLst>
              </p:cNvPr>
              <p:cNvSpPr txBox="1"/>
              <p:nvPr/>
            </p:nvSpPr>
            <p:spPr>
              <a:xfrm rot="18348356">
                <a:off x="3839043" y="1582852"/>
                <a:ext cx="227107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nmt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5B6E9D8F-A38C-E173-381C-0E60E34C89B0}"/>
                  </a:ext>
                </a:extLst>
              </p:cNvPr>
              <p:cNvSpPr txBox="1"/>
              <p:nvPr/>
            </p:nvSpPr>
            <p:spPr>
              <a:xfrm rot="18348356">
                <a:off x="4045606" y="1440225"/>
                <a:ext cx="2858143" cy="2775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75000"/>
                  </a:lnSpc>
                </a:pP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nmt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320B34BC-F2D6-ECCD-555B-ED2EE0E88233}"/>
                  </a:ext>
                </a:extLst>
              </p:cNvPr>
              <p:cNvSpPr txBox="1"/>
              <p:nvPr/>
            </p:nvSpPr>
            <p:spPr>
              <a:xfrm rot="18348356">
                <a:off x="4688658" y="2037071"/>
                <a:ext cx="1220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67630D7D-91C1-BC2A-0C9F-0CEDD0F56A2B}"/>
                  </a:ext>
                </a:extLst>
              </p:cNvPr>
              <p:cNvSpPr txBox="1"/>
              <p:nvPr/>
            </p:nvSpPr>
            <p:spPr>
              <a:xfrm rot="18348356">
                <a:off x="5039988" y="2147049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4A3C1BE0-724B-0E6A-0EFA-FB1838BFEE28}"/>
                </a:ext>
              </a:extLst>
            </p:cNvPr>
            <p:cNvGrpSpPr/>
            <p:nvPr/>
          </p:nvGrpSpPr>
          <p:grpSpPr>
            <a:xfrm>
              <a:off x="2744540" y="3485806"/>
              <a:ext cx="816171" cy="1939342"/>
              <a:chOff x="2744540" y="3485806"/>
              <a:chExt cx="816171" cy="1939342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7909B156-5C5B-4729-0A89-73F9B09715B1}"/>
                  </a:ext>
                </a:extLst>
              </p:cNvPr>
              <p:cNvSpPr txBox="1"/>
              <p:nvPr/>
            </p:nvSpPr>
            <p:spPr>
              <a:xfrm>
                <a:off x="2816251" y="5176803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58DE6582-4843-B08C-70A8-1B1E3C02DDC6}"/>
                  </a:ext>
                </a:extLst>
              </p:cNvPr>
              <p:cNvSpPr txBox="1"/>
              <p:nvPr/>
            </p:nvSpPr>
            <p:spPr>
              <a:xfrm>
                <a:off x="2816250" y="4843565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A965B9CD-C03C-A323-BF65-BB6842DC89AB}"/>
                  </a:ext>
                </a:extLst>
              </p:cNvPr>
              <p:cNvSpPr txBox="1"/>
              <p:nvPr/>
            </p:nvSpPr>
            <p:spPr>
              <a:xfrm>
                <a:off x="2816250" y="4618325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F0BAA428-F401-65B7-4825-6546A3E97FCE}"/>
                  </a:ext>
                </a:extLst>
              </p:cNvPr>
              <p:cNvSpPr txBox="1"/>
              <p:nvPr/>
            </p:nvSpPr>
            <p:spPr>
              <a:xfrm>
                <a:off x="2816249" y="4448755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B3C45352-2E74-E0F4-89BC-F0927F26FECE}"/>
                  </a:ext>
                </a:extLst>
              </p:cNvPr>
              <p:cNvSpPr txBox="1"/>
              <p:nvPr/>
            </p:nvSpPr>
            <p:spPr>
              <a:xfrm>
                <a:off x="2816248" y="4182030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8090EC9A-661F-3522-F3D9-3DD80FF877F1}"/>
                  </a:ext>
                </a:extLst>
              </p:cNvPr>
              <p:cNvSpPr txBox="1"/>
              <p:nvPr/>
            </p:nvSpPr>
            <p:spPr>
              <a:xfrm>
                <a:off x="2818099" y="4305862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直接箭头连接符 45">
                <a:extLst>
                  <a:ext uri="{FF2B5EF4-FFF2-40B4-BE49-F238E27FC236}">
                    <a16:creationId xmlns:a16="http://schemas.microsoft.com/office/drawing/2014/main" id="{BA304263-8AA1-E947-D758-BBC8FAA2309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04644" y="5326212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箭头连接符 48">
                <a:extLst>
                  <a:ext uri="{FF2B5EF4-FFF2-40B4-BE49-F238E27FC236}">
                    <a16:creationId xmlns:a16="http://schemas.microsoft.com/office/drawing/2014/main" id="{19E32045-914A-B8F0-BB22-F780FF8083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04644" y="4970536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箭头连接符 50">
                <a:extLst>
                  <a:ext uri="{FF2B5EF4-FFF2-40B4-BE49-F238E27FC236}">
                    <a16:creationId xmlns:a16="http://schemas.microsoft.com/office/drawing/2014/main" id="{BE5D06DD-312C-6F54-1AE2-44DB1FB8681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04644" y="4742497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箭头连接符 51">
                <a:extLst>
                  <a:ext uri="{FF2B5EF4-FFF2-40B4-BE49-F238E27FC236}">
                    <a16:creationId xmlns:a16="http://schemas.microsoft.com/office/drawing/2014/main" id="{F7491C86-8DC6-9606-3D63-9BE8E5B15B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97341" y="4565758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箭头连接符 52">
                <a:extLst>
                  <a:ext uri="{FF2B5EF4-FFF2-40B4-BE49-F238E27FC236}">
                    <a16:creationId xmlns:a16="http://schemas.microsoft.com/office/drawing/2014/main" id="{20C9A311-B433-C6AC-492D-2FA8A6B523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97341" y="4441694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箭头连接符 53">
                <a:extLst>
                  <a:ext uri="{FF2B5EF4-FFF2-40B4-BE49-F238E27FC236}">
                    <a16:creationId xmlns:a16="http://schemas.microsoft.com/office/drawing/2014/main" id="{6E1837C8-F708-D9DF-085B-D441654C95F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97341" y="4319537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箭头连接符 54">
                <a:extLst>
                  <a:ext uri="{FF2B5EF4-FFF2-40B4-BE49-F238E27FC236}">
                    <a16:creationId xmlns:a16="http://schemas.microsoft.com/office/drawing/2014/main" id="{0A324E68-9E31-8C8E-B27D-097723B1354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04644" y="4214762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1B68240D-4504-D118-441D-24948169F012}"/>
                  </a:ext>
                </a:extLst>
              </p:cNvPr>
              <p:cNvSpPr txBox="1"/>
              <p:nvPr/>
            </p:nvSpPr>
            <p:spPr>
              <a:xfrm>
                <a:off x="2816248" y="4073671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直接箭头连接符 56">
                <a:extLst>
                  <a:ext uri="{FF2B5EF4-FFF2-40B4-BE49-F238E27FC236}">
                    <a16:creationId xmlns:a16="http://schemas.microsoft.com/office/drawing/2014/main" id="{32F92C0D-3E21-5992-D3D8-1440B7F2B01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97341" y="4150468"/>
                <a:ext cx="23874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F7039178-44F3-7B00-C93C-ECB7116BD88E}"/>
                  </a:ext>
                </a:extLst>
              </p:cNvPr>
              <p:cNvSpPr txBox="1"/>
              <p:nvPr/>
            </p:nvSpPr>
            <p:spPr>
              <a:xfrm>
                <a:off x="2816248" y="3971114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9" name="直接箭头连接符 58">
                <a:extLst>
                  <a:ext uri="{FF2B5EF4-FFF2-40B4-BE49-F238E27FC236}">
                    <a16:creationId xmlns:a16="http://schemas.microsoft.com/office/drawing/2014/main" id="{D3D82301-40E6-1FD9-E57C-340D122D181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289431" y="3993829"/>
                <a:ext cx="269165" cy="10255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BE31945F-B848-BE85-16C0-5AD799710E4C}"/>
                  </a:ext>
                </a:extLst>
              </p:cNvPr>
              <p:cNvSpPr txBox="1"/>
              <p:nvPr/>
            </p:nvSpPr>
            <p:spPr>
              <a:xfrm>
                <a:off x="2816248" y="3849557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2" name="直接箭头连接符 61">
                <a:extLst>
                  <a:ext uri="{FF2B5EF4-FFF2-40B4-BE49-F238E27FC236}">
                    <a16:creationId xmlns:a16="http://schemas.microsoft.com/office/drawing/2014/main" id="{1E90CB5D-0D6B-C7BE-61A4-37BDDA35DBA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272711" y="3833107"/>
                <a:ext cx="288000" cy="18491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973AB283-5C93-3B10-0885-4D6496C97073}"/>
                  </a:ext>
                </a:extLst>
              </p:cNvPr>
              <p:cNvSpPr txBox="1"/>
              <p:nvPr/>
            </p:nvSpPr>
            <p:spPr>
              <a:xfrm>
                <a:off x="2753373" y="3678319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4" name="直接箭头连接符 73">
                <a:extLst>
                  <a:ext uri="{FF2B5EF4-FFF2-40B4-BE49-F238E27FC236}">
                    <a16:creationId xmlns:a16="http://schemas.microsoft.com/office/drawing/2014/main" id="{286ACDBA-BFA3-7692-955A-9C0A6EA842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289431" y="3665485"/>
                <a:ext cx="266246" cy="15920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E6C54B0F-CE09-44D1-9358-448C99C06BB5}"/>
                  </a:ext>
                </a:extLst>
              </p:cNvPr>
              <p:cNvSpPr txBox="1"/>
              <p:nvPr/>
            </p:nvSpPr>
            <p:spPr>
              <a:xfrm>
                <a:off x="2744540" y="3485806"/>
                <a:ext cx="679473" cy="24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00bp</a:t>
                </a:r>
                <a:endParaRPr lang="zh-CN" alt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2BF720D3-F08D-F68A-728D-008969C93A0F}"/>
                </a:ext>
              </a:extLst>
            </p:cNvPr>
            <p:cNvSpPr/>
            <p:nvPr/>
          </p:nvSpPr>
          <p:spPr>
            <a:xfrm>
              <a:off x="7086147" y="4495214"/>
              <a:ext cx="631824" cy="20188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8E322D15-FFB6-70D0-EA48-62DF978CBF66}"/>
                </a:ext>
              </a:extLst>
            </p:cNvPr>
            <p:cNvSpPr/>
            <p:nvPr/>
          </p:nvSpPr>
          <p:spPr>
            <a:xfrm>
              <a:off x="6532542" y="4799876"/>
              <a:ext cx="1475043" cy="20188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81" name="直接箭头连接符 80">
              <a:extLst>
                <a:ext uri="{FF2B5EF4-FFF2-40B4-BE49-F238E27FC236}">
                  <a16:creationId xmlns:a16="http://schemas.microsoft.com/office/drawing/2014/main" id="{7806A4DE-EBCA-69E4-C797-FFD7B70432AA}"/>
                </a:ext>
              </a:extLst>
            </p:cNvPr>
            <p:cNvCxnSpPr>
              <a:cxnSpLocks/>
            </p:cNvCxnSpPr>
            <p:nvPr/>
          </p:nvCxnSpPr>
          <p:spPr>
            <a:xfrm>
              <a:off x="7746611" y="4616355"/>
              <a:ext cx="87828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9BA96B70-300E-8624-5B1B-225281FC3ED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28680" y="4900818"/>
              <a:ext cx="734617" cy="559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62A1C6A9-5AA6-D6C3-1C40-08A61A3EEBF4}"/>
                </a:ext>
              </a:extLst>
            </p:cNvPr>
            <p:cNvSpPr txBox="1"/>
            <p:nvPr/>
          </p:nvSpPr>
          <p:spPr>
            <a:xfrm>
              <a:off x="8574496" y="4471436"/>
              <a:ext cx="11843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mt3a</a:t>
              </a:r>
              <a:r>
                <a:rPr lang="en-US" altLang="zh-CN" sz="16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zh-CN" altLang="en-US" sz="1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B74B7E7A-33AC-86B7-B554-BB360F62EAE6}"/>
                </a:ext>
              </a:extLst>
            </p:cNvPr>
            <p:cNvSpPr txBox="1"/>
            <p:nvPr/>
          </p:nvSpPr>
          <p:spPr>
            <a:xfrm>
              <a:off x="8707771" y="4777708"/>
              <a:ext cx="6679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AF15D78D-9F49-5FD3-0993-1936FCE84E8A}"/>
              </a:ext>
            </a:extLst>
          </p:cNvPr>
          <p:cNvSpPr txBox="1"/>
          <p:nvPr/>
        </p:nvSpPr>
        <p:spPr>
          <a:xfrm>
            <a:off x="1039777" y="285242"/>
            <a:ext cx="29887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Appendix Figure S10A</a:t>
            </a:r>
          </a:p>
        </p:txBody>
      </p:sp>
    </p:spTree>
    <p:extLst>
      <p:ext uri="{BB962C8B-B14F-4D97-AF65-F5344CB8AC3E}">
        <p14:creationId xmlns:p14="http://schemas.microsoft.com/office/powerpoint/2010/main" val="42584944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组合 87">
            <a:extLst>
              <a:ext uri="{FF2B5EF4-FFF2-40B4-BE49-F238E27FC236}">
                <a16:creationId xmlns:a16="http://schemas.microsoft.com/office/drawing/2014/main" id="{7EC48E00-0D6C-EE08-3F63-91E55BF82757}"/>
              </a:ext>
            </a:extLst>
          </p:cNvPr>
          <p:cNvGrpSpPr/>
          <p:nvPr/>
        </p:nvGrpSpPr>
        <p:grpSpPr>
          <a:xfrm>
            <a:off x="1590909" y="30337"/>
            <a:ext cx="3993969" cy="6407684"/>
            <a:chOff x="1590909" y="30337"/>
            <a:chExt cx="3993969" cy="6407684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032C57C-D81F-508C-5D4D-F2A22FBAB3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740" t="8875" r="17204" b="49731"/>
            <a:stretch/>
          </p:blipFill>
          <p:spPr>
            <a:xfrm>
              <a:off x="2164921" y="2622021"/>
              <a:ext cx="3419957" cy="3816000"/>
            </a:xfrm>
            <a:prstGeom prst="rect">
              <a:avLst/>
            </a:prstGeom>
          </p:spPr>
        </p:pic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FFA2F287-D24C-E88D-3364-7CB06E31AF7A}"/>
                </a:ext>
              </a:extLst>
            </p:cNvPr>
            <p:cNvGrpSpPr/>
            <p:nvPr/>
          </p:nvGrpSpPr>
          <p:grpSpPr>
            <a:xfrm>
              <a:off x="2473537" y="30337"/>
              <a:ext cx="2147217" cy="2858143"/>
              <a:chOff x="3549712" y="149909"/>
              <a:chExt cx="2147217" cy="2858143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3E35B2D5-0A9D-042B-F803-BD0DDC0A3911}"/>
                  </a:ext>
                </a:extLst>
              </p:cNvPr>
              <p:cNvSpPr txBox="1"/>
              <p:nvPr/>
            </p:nvSpPr>
            <p:spPr>
              <a:xfrm rot="18348356">
                <a:off x="3679122" y="1815789"/>
                <a:ext cx="17102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ABDD408E-E8CA-3A2C-FBDB-12AA3D8D867B}"/>
                  </a:ext>
                </a:extLst>
              </p:cNvPr>
              <p:cNvSpPr txBox="1"/>
              <p:nvPr/>
            </p:nvSpPr>
            <p:spPr>
              <a:xfrm rot="18348356">
                <a:off x="3231325" y="2098928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9728F9B-08BC-2624-1C19-B70DF7366781}"/>
                  </a:ext>
                </a:extLst>
              </p:cNvPr>
              <p:cNvSpPr txBox="1"/>
              <p:nvPr/>
            </p:nvSpPr>
            <p:spPr>
              <a:xfrm rot="18348356">
                <a:off x="3501456" y="2012233"/>
                <a:ext cx="11891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F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BBE5B5FC-2DD3-D5BA-9736-B02C21C5ADCF}"/>
                  </a:ext>
                </a:extLst>
              </p:cNvPr>
              <p:cNvSpPr txBox="1"/>
              <p:nvPr/>
            </p:nvSpPr>
            <p:spPr>
              <a:xfrm rot="18348356">
                <a:off x="3875865" y="1582852"/>
                <a:ext cx="227107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nmt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E1EED587-8FF2-53F3-17C4-453D13BE1B68}"/>
                  </a:ext>
                </a:extLst>
              </p:cNvPr>
              <p:cNvSpPr txBox="1"/>
              <p:nvPr/>
            </p:nvSpPr>
            <p:spPr>
              <a:xfrm rot="18348356">
                <a:off x="4064017" y="1440225"/>
                <a:ext cx="2858143" cy="2775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75000"/>
                  </a:lnSpc>
                </a:pP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P3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F/</a:t>
                </a:r>
                <a:r>
                  <a:rPr lang="en-US" altLang="zh-CN" sz="16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nmt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(1,3a)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F/2F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ysM</a:t>
                </a:r>
                <a:r>
                  <a:rPr lang="en-US" altLang="zh-CN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endParaRPr lang="zh-CN" altLang="en-US" sz="16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E0EF460-54A8-B069-7DF1-82BFC9C5C71E}"/>
                  </a:ext>
                </a:extLst>
              </p:cNvPr>
              <p:cNvSpPr txBox="1"/>
              <p:nvPr/>
            </p:nvSpPr>
            <p:spPr>
              <a:xfrm rot="18348356">
                <a:off x="4688658" y="2037071"/>
                <a:ext cx="1220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E443BA6F-8F03-F49E-DAD9-DE7EFB22BC89}"/>
                  </a:ext>
                </a:extLst>
              </p:cNvPr>
              <p:cNvSpPr txBox="1"/>
              <p:nvPr/>
            </p:nvSpPr>
            <p:spPr>
              <a:xfrm rot="18348356">
                <a:off x="5039988" y="2147049"/>
                <a:ext cx="9753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3FEB366-25FD-0B71-4CD8-E89DF95CB0C5}"/>
                </a:ext>
              </a:extLst>
            </p:cNvPr>
            <p:cNvSpPr txBox="1"/>
            <p:nvPr/>
          </p:nvSpPr>
          <p:spPr>
            <a:xfrm>
              <a:off x="1653787" y="4937538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F893853-90AB-8ADD-75D0-14317E487B09}"/>
                </a:ext>
              </a:extLst>
            </p:cNvPr>
            <p:cNvSpPr txBox="1"/>
            <p:nvPr/>
          </p:nvSpPr>
          <p:spPr>
            <a:xfrm>
              <a:off x="1653786" y="4635828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B9B8209-D053-5445-B94B-9B03FC26537A}"/>
                </a:ext>
              </a:extLst>
            </p:cNvPr>
            <p:cNvSpPr txBox="1"/>
            <p:nvPr/>
          </p:nvSpPr>
          <p:spPr>
            <a:xfrm>
              <a:off x="1653786" y="4397076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069E3A9-AF39-53EB-A96A-6EA7CB1675F5}"/>
                </a:ext>
              </a:extLst>
            </p:cNvPr>
            <p:cNvSpPr txBox="1"/>
            <p:nvPr/>
          </p:nvSpPr>
          <p:spPr>
            <a:xfrm>
              <a:off x="1653785" y="4236514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4FFBF5B-05FA-BC26-92DD-081F64817959}"/>
                </a:ext>
              </a:extLst>
            </p:cNvPr>
            <p:cNvSpPr txBox="1"/>
            <p:nvPr/>
          </p:nvSpPr>
          <p:spPr>
            <a:xfrm>
              <a:off x="1653784" y="3992309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B64A2FC-7FE0-195F-A960-A386F9F9C72A}"/>
                </a:ext>
              </a:extLst>
            </p:cNvPr>
            <p:cNvSpPr txBox="1"/>
            <p:nvPr/>
          </p:nvSpPr>
          <p:spPr>
            <a:xfrm>
              <a:off x="1655635" y="4102629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箭头连接符 28">
              <a:extLst>
                <a:ext uri="{FF2B5EF4-FFF2-40B4-BE49-F238E27FC236}">
                  <a16:creationId xmlns:a16="http://schemas.microsoft.com/office/drawing/2014/main" id="{CE96B779-DFAC-EE76-B2C8-4E17E364A7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42180" y="5086947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>
              <a:extLst>
                <a:ext uri="{FF2B5EF4-FFF2-40B4-BE49-F238E27FC236}">
                  <a16:creationId xmlns:a16="http://schemas.microsoft.com/office/drawing/2014/main" id="{AF51524C-6FE4-8857-2F6D-FD49A3BA78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42180" y="4762799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箭头连接符 30">
              <a:extLst>
                <a:ext uri="{FF2B5EF4-FFF2-40B4-BE49-F238E27FC236}">
                  <a16:creationId xmlns:a16="http://schemas.microsoft.com/office/drawing/2014/main" id="{920AA2FA-2D9A-7322-E922-2A07568184E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42180" y="4521248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>
              <a:extLst>
                <a:ext uri="{FF2B5EF4-FFF2-40B4-BE49-F238E27FC236}">
                  <a16:creationId xmlns:a16="http://schemas.microsoft.com/office/drawing/2014/main" id="{142FD3D0-3A8D-0D36-B551-841BEC47D2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34877" y="4353517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>
              <a:extLst>
                <a:ext uri="{FF2B5EF4-FFF2-40B4-BE49-F238E27FC236}">
                  <a16:creationId xmlns:a16="http://schemas.microsoft.com/office/drawing/2014/main" id="{B2627E80-007D-7628-194E-E64BED9DA3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34877" y="4224949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>
              <a:extLst>
                <a:ext uri="{FF2B5EF4-FFF2-40B4-BE49-F238E27FC236}">
                  <a16:creationId xmlns:a16="http://schemas.microsoft.com/office/drawing/2014/main" id="{FAAD46C2-BC71-775D-5669-FD79B67B13B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34877" y="4120808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箭头连接符 34">
              <a:extLst>
                <a:ext uri="{FF2B5EF4-FFF2-40B4-BE49-F238E27FC236}">
                  <a16:creationId xmlns:a16="http://schemas.microsoft.com/office/drawing/2014/main" id="{51FC7DBF-8F6A-FBBA-689D-D3BA9FE47F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42180" y="4016033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012046A5-C038-69FE-A69C-7F0F27120C8D}"/>
                </a:ext>
              </a:extLst>
            </p:cNvPr>
            <p:cNvSpPr txBox="1"/>
            <p:nvPr/>
          </p:nvSpPr>
          <p:spPr>
            <a:xfrm>
              <a:off x="1651933" y="3880924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箭头连接符 36">
              <a:extLst>
                <a:ext uri="{FF2B5EF4-FFF2-40B4-BE49-F238E27FC236}">
                  <a16:creationId xmlns:a16="http://schemas.microsoft.com/office/drawing/2014/main" id="{D9558820-D962-0A44-D0F1-34C3A627CDE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110247" y="3895759"/>
              <a:ext cx="263370" cy="5147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C5F006B-25D2-F438-55A9-13816D0F9B49}"/>
                </a:ext>
              </a:extLst>
            </p:cNvPr>
            <p:cNvSpPr txBox="1"/>
            <p:nvPr/>
          </p:nvSpPr>
          <p:spPr>
            <a:xfrm>
              <a:off x="1651933" y="3771587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接箭头连接符 38">
              <a:extLst>
                <a:ext uri="{FF2B5EF4-FFF2-40B4-BE49-F238E27FC236}">
                  <a16:creationId xmlns:a16="http://schemas.microsoft.com/office/drawing/2014/main" id="{23E656E4-EF8F-F580-5006-92B09F7D168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126967" y="3781588"/>
              <a:ext cx="269165" cy="10255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AF011422-E50B-1409-3CD4-506E4B705DE9}"/>
                </a:ext>
              </a:extLst>
            </p:cNvPr>
            <p:cNvSpPr txBox="1"/>
            <p:nvPr/>
          </p:nvSpPr>
          <p:spPr>
            <a:xfrm>
              <a:off x="1653784" y="3637316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箭头连接符 40">
              <a:extLst>
                <a:ext uri="{FF2B5EF4-FFF2-40B4-BE49-F238E27FC236}">
                  <a16:creationId xmlns:a16="http://schemas.microsoft.com/office/drawing/2014/main" id="{0753A926-EDFD-7D33-7B2C-2051883230B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110247" y="3616362"/>
              <a:ext cx="288000" cy="18491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6E08D12-13A4-641C-7C33-5A5790C0FAE7}"/>
                </a:ext>
              </a:extLst>
            </p:cNvPr>
            <p:cNvSpPr txBox="1"/>
            <p:nvPr/>
          </p:nvSpPr>
          <p:spPr>
            <a:xfrm>
              <a:off x="1590909" y="3493107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0337DBF9-7310-699F-EFBC-D84FAF82955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126967" y="3462252"/>
              <a:ext cx="266246" cy="1592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F2AC4BBD-75C9-0C72-020B-7425C93DA56A}"/>
                </a:ext>
              </a:extLst>
            </p:cNvPr>
            <p:cNvSpPr txBox="1"/>
            <p:nvPr/>
          </p:nvSpPr>
          <p:spPr>
            <a:xfrm>
              <a:off x="1595588" y="3323109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66F79A9E-C967-E84B-BC34-6F404E9779E4}"/>
                </a:ext>
              </a:extLst>
            </p:cNvPr>
            <p:cNvSpPr txBox="1"/>
            <p:nvPr/>
          </p:nvSpPr>
          <p:spPr>
            <a:xfrm>
              <a:off x="4262963" y="3851770"/>
              <a:ext cx="951887" cy="3407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P3</a:t>
              </a:r>
              <a:r>
                <a:rPr lang="en-US" altLang="zh-CN" sz="16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zh-CN" altLang="en-US" sz="1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8147D543-9E8C-CCE3-5B06-A26B82E2C25B}"/>
                </a:ext>
              </a:extLst>
            </p:cNvPr>
            <p:cNvSpPr txBox="1"/>
            <p:nvPr/>
          </p:nvSpPr>
          <p:spPr>
            <a:xfrm>
              <a:off x="4522087" y="4528370"/>
              <a:ext cx="6794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AE4D270D-B9C5-4078-33DC-77BD77E886DC}"/>
                </a:ext>
              </a:extLst>
            </p:cNvPr>
            <p:cNvSpPr/>
            <p:nvPr/>
          </p:nvSpPr>
          <p:spPr>
            <a:xfrm>
              <a:off x="3221614" y="4264398"/>
              <a:ext cx="884874" cy="180139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9" name="直接箭头连接符 48">
              <a:extLst>
                <a:ext uri="{FF2B5EF4-FFF2-40B4-BE49-F238E27FC236}">
                  <a16:creationId xmlns:a16="http://schemas.microsoft.com/office/drawing/2014/main" id="{CA725E03-4D30-A6B3-F2E4-121BED767FE6}"/>
                </a:ext>
              </a:extLst>
            </p:cNvPr>
            <p:cNvCxnSpPr>
              <a:cxnSpLocks/>
            </p:cNvCxnSpPr>
            <p:nvPr/>
          </p:nvCxnSpPr>
          <p:spPr>
            <a:xfrm>
              <a:off x="4106488" y="4475687"/>
              <a:ext cx="437803" cy="16973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61953D1F-B226-CBD1-647F-1A84368A1CCD}"/>
                </a:ext>
              </a:extLst>
            </p:cNvPr>
            <p:cNvSpPr/>
            <p:nvPr/>
          </p:nvSpPr>
          <p:spPr>
            <a:xfrm>
              <a:off x="2686442" y="4083298"/>
              <a:ext cx="1152797" cy="180139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1" name="直接箭头连接符 50">
              <a:extLst>
                <a:ext uri="{FF2B5EF4-FFF2-40B4-BE49-F238E27FC236}">
                  <a16:creationId xmlns:a16="http://schemas.microsoft.com/office/drawing/2014/main" id="{F4DFB55C-9256-90AF-DD2F-D0401ECD52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77193" y="3969043"/>
              <a:ext cx="431386" cy="13358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60849304-BDBD-CCFE-B075-C6662FD01692}"/>
              </a:ext>
            </a:extLst>
          </p:cNvPr>
          <p:cNvGrpSpPr/>
          <p:nvPr/>
        </p:nvGrpSpPr>
        <p:grpSpPr>
          <a:xfrm>
            <a:off x="6956897" y="0"/>
            <a:ext cx="4004819" cy="6438021"/>
            <a:chOff x="6956897" y="0"/>
            <a:chExt cx="4004819" cy="643802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5E657A7-148D-E936-91DB-A68BFBF264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97" t="11634" r="36626" b="42082"/>
            <a:stretch/>
          </p:blipFill>
          <p:spPr>
            <a:xfrm>
              <a:off x="7474225" y="2622021"/>
              <a:ext cx="2319528" cy="3816000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BA0DBC03-5493-CA08-31B0-E40A22E46FCB}"/>
                </a:ext>
              </a:extLst>
            </p:cNvPr>
            <p:cNvSpPr txBox="1"/>
            <p:nvPr/>
          </p:nvSpPr>
          <p:spPr>
            <a:xfrm rot="18348356">
              <a:off x="7943635" y="1665880"/>
              <a:ext cx="17102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EP3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</a:t>
              </a:r>
              <a:r>
                <a:rPr lang="en-US" altLang="zh-CN" sz="16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altLang="zh-CN" sz="16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zh-CN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A02E127-48C6-3242-FCF2-772F6D0A29F1}"/>
                </a:ext>
              </a:extLst>
            </p:cNvPr>
            <p:cNvSpPr txBox="1"/>
            <p:nvPr/>
          </p:nvSpPr>
          <p:spPr>
            <a:xfrm rot="18348356">
              <a:off x="7500377" y="1949019"/>
              <a:ext cx="975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093E886-59FA-3121-07A3-212DB17E1883}"/>
                </a:ext>
              </a:extLst>
            </p:cNvPr>
            <p:cNvSpPr txBox="1"/>
            <p:nvPr/>
          </p:nvSpPr>
          <p:spPr>
            <a:xfrm rot="18348356">
              <a:off x="7790517" y="1862324"/>
              <a:ext cx="11891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EP3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F</a:t>
              </a:r>
              <a:endParaRPr lang="zh-CN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AE16FF6-1D32-0BEE-6E0E-0F04B5FD5947}"/>
                </a:ext>
              </a:extLst>
            </p:cNvPr>
            <p:cNvSpPr txBox="1"/>
            <p:nvPr/>
          </p:nvSpPr>
          <p:spPr>
            <a:xfrm rot="18348356">
              <a:off x="8085145" y="1432943"/>
              <a:ext cx="22710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Dnmt(1,3a)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F/2F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zh-CN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B4E12F0-C5FB-BEBE-FB50-ECAEAAF51085}"/>
                </a:ext>
              </a:extLst>
            </p:cNvPr>
            <p:cNvSpPr txBox="1"/>
            <p:nvPr/>
          </p:nvSpPr>
          <p:spPr>
            <a:xfrm rot="18348356">
              <a:off x="8291708" y="1290316"/>
              <a:ext cx="2858143" cy="277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75000"/>
                </a:lnSpc>
              </a:pP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EP3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/</a:t>
              </a:r>
              <a:r>
                <a:rPr lang="en-US" altLang="zh-CN" sz="16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Dnmt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1,3a)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F/2F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altLang="zh-CN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zh-CN" alt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B8E49796-BD5F-1672-4D56-4EB3AEFF4122}"/>
                </a:ext>
              </a:extLst>
            </p:cNvPr>
            <p:cNvSpPr txBox="1"/>
            <p:nvPr/>
          </p:nvSpPr>
          <p:spPr>
            <a:xfrm rot="18348356">
              <a:off x="8934760" y="1887162"/>
              <a:ext cx="12203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D422280-A58C-01B7-54CF-E9148D3F171A}"/>
                </a:ext>
              </a:extLst>
            </p:cNvPr>
            <p:cNvSpPr txBox="1"/>
            <p:nvPr/>
          </p:nvSpPr>
          <p:spPr>
            <a:xfrm rot="18348356">
              <a:off x="9225128" y="1997140"/>
              <a:ext cx="9753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Marker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66C9D470-E623-E85E-A9EC-85218CAB3BE1}"/>
                </a:ext>
              </a:extLst>
            </p:cNvPr>
            <p:cNvSpPr/>
            <p:nvPr/>
          </p:nvSpPr>
          <p:spPr>
            <a:xfrm>
              <a:off x="8165789" y="4937538"/>
              <a:ext cx="1275121" cy="149409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3B1D1876-4FC3-9F1F-BFB8-000C08600F9C}"/>
                </a:ext>
              </a:extLst>
            </p:cNvPr>
            <p:cNvSpPr/>
            <p:nvPr/>
          </p:nvSpPr>
          <p:spPr>
            <a:xfrm>
              <a:off x="8372710" y="4788611"/>
              <a:ext cx="787916" cy="149409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6" name="直接箭头连接符 55">
              <a:extLst>
                <a:ext uri="{FF2B5EF4-FFF2-40B4-BE49-F238E27FC236}">
                  <a16:creationId xmlns:a16="http://schemas.microsoft.com/office/drawing/2014/main" id="{42D22EB1-BCB1-C9AE-89C6-5722D8787F7F}"/>
                </a:ext>
              </a:extLst>
            </p:cNvPr>
            <p:cNvCxnSpPr>
              <a:cxnSpLocks/>
              <a:endCxn id="9" idx="3"/>
            </p:cNvCxnSpPr>
            <p:nvPr/>
          </p:nvCxnSpPr>
          <p:spPr>
            <a:xfrm flipV="1">
              <a:off x="9135473" y="4530021"/>
              <a:ext cx="658280" cy="24898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箭头连接符 56">
              <a:extLst>
                <a:ext uri="{FF2B5EF4-FFF2-40B4-BE49-F238E27FC236}">
                  <a16:creationId xmlns:a16="http://schemas.microsoft.com/office/drawing/2014/main" id="{F6972441-602B-D0A5-E20A-546A2A86981E}"/>
                </a:ext>
              </a:extLst>
            </p:cNvPr>
            <p:cNvCxnSpPr>
              <a:cxnSpLocks/>
            </p:cNvCxnSpPr>
            <p:nvPr/>
          </p:nvCxnSpPr>
          <p:spPr>
            <a:xfrm>
              <a:off x="9470226" y="5143476"/>
              <a:ext cx="437803" cy="16973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0783EBA8-216C-05B2-8E1B-8E6C8459359C}"/>
                </a:ext>
              </a:extLst>
            </p:cNvPr>
            <p:cNvSpPr txBox="1"/>
            <p:nvPr/>
          </p:nvSpPr>
          <p:spPr>
            <a:xfrm>
              <a:off x="9850900" y="5158843"/>
              <a:ext cx="6873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H</a:t>
              </a:r>
              <a:endPara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5DA4D67-60AA-7CE6-AB75-BA48D4F8E80A}"/>
                </a:ext>
              </a:extLst>
            </p:cNvPr>
            <p:cNvSpPr txBox="1"/>
            <p:nvPr/>
          </p:nvSpPr>
          <p:spPr>
            <a:xfrm>
              <a:off x="9753415" y="4371490"/>
              <a:ext cx="12083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M</a:t>
              </a:r>
              <a:r>
                <a:rPr lang="en-US" altLang="zh-CN" sz="1600" baseline="300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endParaRPr lang="zh-CN" altLang="en-US" sz="16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F3137452-3765-60A6-21F1-A75253B706CB}"/>
                </a:ext>
              </a:extLst>
            </p:cNvPr>
            <p:cNvSpPr txBox="1"/>
            <p:nvPr/>
          </p:nvSpPr>
          <p:spPr>
            <a:xfrm>
              <a:off x="7028608" y="5758116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8DD926D-2C27-DDFB-9938-3F8A7F7D5CC2}"/>
                </a:ext>
              </a:extLst>
            </p:cNvPr>
            <p:cNvSpPr txBox="1"/>
            <p:nvPr/>
          </p:nvSpPr>
          <p:spPr>
            <a:xfrm>
              <a:off x="7028607" y="538281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E146B44B-F49E-0ACC-4D76-0A8FC45C9BB1}"/>
                </a:ext>
              </a:extLst>
            </p:cNvPr>
            <p:cNvSpPr txBox="1"/>
            <p:nvPr/>
          </p:nvSpPr>
          <p:spPr>
            <a:xfrm>
              <a:off x="7028607" y="5051481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6ED92228-9B2D-C227-1C31-3EEBC2323349}"/>
                </a:ext>
              </a:extLst>
            </p:cNvPr>
            <p:cNvSpPr txBox="1"/>
            <p:nvPr/>
          </p:nvSpPr>
          <p:spPr>
            <a:xfrm>
              <a:off x="7028606" y="4807398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97B0EC4A-7DC4-2219-3208-ADB75364A7B3}"/>
                </a:ext>
              </a:extLst>
            </p:cNvPr>
            <p:cNvSpPr txBox="1"/>
            <p:nvPr/>
          </p:nvSpPr>
          <p:spPr>
            <a:xfrm>
              <a:off x="7028605" y="447234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8ACB0F4C-5AC4-4D95-9861-AD2863A74864}"/>
                </a:ext>
              </a:extLst>
            </p:cNvPr>
            <p:cNvSpPr txBox="1"/>
            <p:nvPr/>
          </p:nvSpPr>
          <p:spPr>
            <a:xfrm>
              <a:off x="7030456" y="4620701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直接箭头连接符 67">
              <a:extLst>
                <a:ext uri="{FF2B5EF4-FFF2-40B4-BE49-F238E27FC236}">
                  <a16:creationId xmlns:a16="http://schemas.microsoft.com/office/drawing/2014/main" id="{22698206-C2DB-147A-063B-89E9675497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0055" y="5907525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箭头连接符 68">
              <a:extLst>
                <a:ext uri="{FF2B5EF4-FFF2-40B4-BE49-F238E27FC236}">
                  <a16:creationId xmlns:a16="http://schemas.microsoft.com/office/drawing/2014/main" id="{90E180B4-24A9-024F-386C-3D4DC17229C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0055" y="5527301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箭头连接符 69">
              <a:extLst>
                <a:ext uri="{FF2B5EF4-FFF2-40B4-BE49-F238E27FC236}">
                  <a16:creationId xmlns:a16="http://schemas.microsoft.com/office/drawing/2014/main" id="{86A668D7-E754-AF23-A4AE-A56E68C956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0055" y="5182659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箭头连接符 70">
              <a:extLst>
                <a:ext uri="{FF2B5EF4-FFF2-40B4-BE49-F238E27FC236}">
                  <a16:creationId xmlns:a16="http://schemas.microsoft.com/office/drawing/2014/main" id="{8ADF9C2A-F7BA-0FBC-DCDC-E2E6D766B6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72752" y="4943654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箭头连接符 71">
              <a:extLst>
                <a:ext uri="{FF2B5EF4-FFF2-40B4-BE49-F238E27FC236}">
                  <a16:creationId xmlns:a16="http://schemas.microsoft.com/office/drawing/2014/main" id="{172CD354-36E0-A583-64A5-9B8434E1EEB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80055" y="4762799"/>
              <a:ext cx="23874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箭头连接符 72">
              <a:extLst>
                <a:ext uri="{FF2B5EF4-FFF2-40B4-BE49-F238E27FC236}">
                  <a16:creationId xmlns:a16="http://schemas.microsoft.com/office/drawing/2014/main" id="{902097B1-8016-1CE3-24A4-2D29273085B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12009" y="4600108"/>
              <a:ext cx="387943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箭头连接符 73">
              <a:extLst>
                <a:ext uri="{FF2B5EF4-FFF2-40B4-BE49-F238E27FC236}">
                  <a16:creationId xmlns:a16="http://schemas.microsoft.com/office/drawing/2014/main" id="{A4205191-71A3-73AD-140F-961FA8966EE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25833" y="4484859"/>
              <a:ext cx="37411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97507B5C-7DE4-D310-6CF8-64F84C015059}"/>
                </a:ext>
              </a:extLst>
            </p:cNvPr>
            <p:cNvSpPr txBox="1"/>
            <p:nvPr/>
          </p:nvSpPr>
          <p:spPr>
            <a:xfrm>
              <a:off x="7028605" y="435347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接箭头连接符 75">
              <a:extLst>
                <a:ext uri="{FF2B5EF4-FFF2-40B4-BE49-F238E27FC236}">
                  <a16:creationId xmlns:a16="http://schemas.microsoft.com/office/drawing/2014/main" id="{7B0F2A93-89FE-EC23-0339-964B1790C9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30716" y="4363704"/>
              <a:ext cx="369236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86D84C16-C72A-108B-68E8-74B13DF123FB}"/>
                </a:ext>
              </a:extLst>
            </p:cNvPr>
            <p:cNvSpPr txBox="1"/>
            <p:nvPr/>
          </p:nvSpPr>
          <p:spPr>
            <a:xfrm>
              <a:off x="7028605" y="4222890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接箭头连接符 77">
              <a:extLst>
                <a:ext uri="{FF2B5EF4-FFF2-40B4-BE49-F238E27FC236}">
                  <a16:creationId xmlns:a16="http://schemas.microsoft.com/office/drawing/2014/main" id="{87AA7E64-E563-71DA-6635-DE4732CC0AE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12009" y="4142294"/>
              <a:ext cx="342403" cy="13019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9C39DC21-6F22-1ACD-78A2-788106176BBB}"/>
                </a:ext>
              </a:extLst>
            </p:cNvPr>
            <p:cNvSpPr txBox="1"/>
            <p:nvPr/>
          </p:nvSpPr>
          <p:spPr>
            <a:xfrm>
              <a:off x="7020229" y="402183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接箭头连接符 79">
              <a:extLst>
                <a:ext uri="{FF2B5EF4-FFF2-40B4-BE49-F238E27FC236}">
                  <a16:creationId xmlns:a16="http://schemas.microsoft.com/office/drawing/2014/main" id="{8CF85B3A-CD5C-2612-C50A-FAC19A6826F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69156" y="3998862"/>
              <a:ext cx="288000" cy="18491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B8D7A5AC-13A6-73A4-9656-DACDCA7D9341}"/>
                </a:ext>
              </a:extLst>
            </p:cNvPr>
            <p:cNvSpPr txBox="1"/>
            <p:nvPr/>
          </p:nvSpPr>
          <p:spPr>
            <a:xfrm>
              <a:off x="6965730" y="3842504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接箭头连接符 81">
              <a:extLst>
                <a:ext uri="{FF2B5EF4-FFF2-40B4-BE49-F238E27FC236}">
                  <a16:creationId xmlns:a16="http://schemas.microsoft.com/office/drawing/2014/main" id="{22669199-CDF2-384D-23C0-B61392695CB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66301" y="3774718"/>
              <a:ext cx="266246" cy="1592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572BF40B-B720-42F7-217B-D7456C97ABD1}"/>
                </a:ext>
              </a:extLst>
            </p:cNvPr>
            <p:cNvSpPr txBox="1"/>
            <p:nvPr/>
          </p:nvSpPr>
          <p:spPr>
            <a:xfrm>
              <a:off x="6956897" y="3594625"/>
              <a:ext cx="679473" cy="24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0bp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BF42582B-B521-B1AF-7945-ADC94EE0E393}"/>
              </a:ext>
            </a:extLst>
          </p:cNvPr>
          <p:cNvSpPr txBox="1"/>
          <p:nvPr/>
        </p:nvSpPr>
        <p:spPr>
          <a:xfrm>
            <a:off x="1039777" y="285242"/>
            <a:ext cx="29887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Appendix Figure S10A</a:t>
            </a:r>
          </a:p>
        </p:txBody>
      </p:sp>
    </p:spTree>
    <p:extLst>
      <p:ext uri="{BB962C8B-B14F-4D97-AF65-F5344CB8AC3E}">
        <p14:creationId xmlns:p14="http://schemas.microsoft.com/office/powerpoint/2010/main" val="223680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157</Words>
  <Application>Microsoft Office PowerPoint</Application>
  <PresentationFormat>宽屏</PresentationFormat>
  <Paragraphs>7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inxiu li</dc:creator>
  <cp:lastModifiedBy>yinxiu li</cp:lastModifiedBy>
  <cp:revision>2</cp:revision>
  <dcterms:created xsi:type="dcterms:W3CDTF">2025-04-24T11:39:42Z</dcterms:created>
  <dcterms:modified xsi:type="dcterms:W3CDTF">2025-04-24T14:44:28Z</dcterms:modified>
</cp:coreProperties>
</file>